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FF3C0A-30A4-46D1-BE29-253D81DC135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274466-524E-4810-9172-8FD689A4A0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73E8E0-ACA1-4946-95BC-704A6FED50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0F5C56-52B1-43B2-B543-4584EF9A70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8801F8-5BDB-4771-BB57-78E4EA3A64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7FCE12-C2E7-4E97-B6E3-4F40FBB553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169215-F701-4AE8-AD84-63C868B734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8CA5B0-59F6-4C3A-BCA4-FF1E034129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438D9F-9BDC-4363-AA76-1B54A242FE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A0723A-ACC8-4335-84D4-4F6D58E53B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19D28A-61E8-457C-A199-230ACDB842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D72C2-6B46-4C72-9BAF-EEA416D8A9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96B39F-1482-448A-B087-56AA0DF00734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5" descr="foto placche"/>
          <p:cNvPicPr/>
          <p:nvPr/>
        </p:nvPicPr>
        <p:blipFill>
          <a:blip r:embed="rId1"/>
          <a:stretch/>
        </p:blipFill>
        <p:spPr>
          <a:xfrm>
            <a:off x="1447920" y="2286000"/>
            <a:ext cx="3724200" cy="37339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459000" y="579600"/>
            <a:ext cx="54097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Supplementary Figure S5: :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Phage plaque assay using the </a:t>
            </a:r>
            <a:r>
              <a:rPr b="0" i="1" lang="it-IT" sz="1200" spc="-1" strike="noStrike">
                <a:solidFill>
                  <a:srgbClr val="000000"/>
                </a:solidFill>
                <a:latin typeface="Times New Roman"/>
              </a:rPr>
              <a:t>S. pneumoniae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indicator strain Rx1. This figure shows the Rx1 lawn lysis due to </a:t>
            </a:r>
            <a:r>
              <a:rPr b="0" lang="it-IT" sz="1200" spc="-1" strike="noStrike">
                <a:solidFill>
                  <a:srgbClr val="000000"/>
                </a:solidFill>
                <a:latin typeface="Symbol"/>
                <a:ea typeface="Symbol"/>
              </a:rPr>
              <a:t>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Spn_200  activit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28T09:36:53Z</dcterms:created>
  <dc:creator>Romina</dc:creator>
  <dc:description/>
  <dc:language>en-US</dc:language>
  <cp:lastModifiedBy>Romina</cp:lastModifiedBy>
  <dcterms:modified xsi:type="dcterms:W3CDTF">2010-10-07T15:40:30Z</dcterms:modified>
  <cp:revision>5</cp:revision>
  <dc:subject/>
  <dc:title>Presentazione di PowerPoint</dc:title>
</cp:coreProperties>
</file>